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73" r:id="rId3"/>
    <p:sldId id="275" r:id="rId4"/>
  </p:sldIdLst>
  <p:sldSz cx="6858000" cy="990282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32" userDrawn="1">
          <p15:clr>
            <a:srgbClr val="A4A3A4"/>
          </p15:clr>
        </p15:guide>
        <p15:guide id="2" pos="21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2512" y="64"/>
      </p:cViewPr>
      <p:guideLst>
        <p:guide orient="horz" pos="3132"/>
        <p:guide pos="216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476" y="1143000"/>
            <a:ext cx="2137048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674325" y="1320480"/>
            <a:ext cx="5512050" cy="371190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674325" y="5141554"/>
            <a:ext cx="5512050" cy="212628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1117729"/>
            <a:ext cx="6172200" cy="791768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3462361"/>
            <a:ext cx="5512050" cy="159601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5141554"/>
            <a:ext cx="5512050" cy="727824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2152278"/>
            <a:ext cx="6170175" cy="687273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5557453"/>
            <a:ext cx="4369950" cy="110733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6664785"/>
            <a:ext cx="4369950" cy="1252896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2167875"/>
            <a:ext cx="2911950" cy="685713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2167875"/>
            <a:ext cx="2911950" cy="6857138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2027509"/>
            <a:ext cx="3005100" cy="597855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2027509"/>
            <a:ext cx="3005100" cy="597855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2245856"/>
            <a:ext cx="2943606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2245856"/>
            <a:ext cx="2940300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1320480"/>
            <a:ext cx="587250" cy="726264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1320480"/>
            <a:ext cx="5157675" cy="726264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878587"/>
            <a:ext cx="6170175" cy="1018953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2152278"/>
            <a:ext cx="6170175" cy="68727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9118590"/>
            <a:ext cx="222750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ea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9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9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9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9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63.xml"/><Relationship Id="rId4" Type="http://schemas.openxmlformats.org/officeDocument/2006/relationships/image" Target="../media/image7.tiff"/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 descr="UMAP_GZMK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8900" y="561975"/>
            <a:ext cx="1715770" cy="1715770"/>
          </a:xfrm>
          <a:prstGeom prst="rect">
            <a:avLst/>
          </a:prstGeom>
        </p:spPr>
      </p:pic>
      <p:pic>
        <p:nvPicPr>
          <p:cNvPr id="15" name="图片 14" descr="UMAP_LYAR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96435" y="527685"/>
            <a:ext cx="1751965" cy="1751965"/>
          </a:xfrm>
          <a:prstGeom prst="rect">
            <a:avLst/>
          </a:prstGeom>
        </p:spPr>
      </p:pic>
      <p:pic>
        <p:nvPicPr>
          <p:cNvPr id="20" name="图片 19" descr="UMAP_KLRG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9190" y="530225"/>
            <a:ext cx="1752600" cy="1752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2471" y="2451030"/>
            <a:ext cx="64064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503050405090304"/>
                <a:ea typeface="Times New Roman" panose="02020503050405090304"/>
              </a:rPr>
              <a:t>Supplementary Figure 1. The UMAP of the gene expression level (</a:t>
            </a:r>
            <a:r>
              <a:rPr lang="en-US" altLang="zh-CN" sz="1200" i="1" dirty="0">
                <a:latin typeface="Times New Roman" panose="02020503050405090304"/>
                <a:ea typeface="Times New Roman" panose="02020503050405090304"/>
              </a:rPr>
              <a:t>GZMK, KLRG1 </a:t>
            </a:r>
            <a:r>
              <a:rPr lang="en-US" altLang="zh-CN" sz="1200" dirty="0">
                <a:latin typeface="Times New Roman" panose="02020503050405090304"/>
                <a:ea typeface="Times New Roman" panose="02020503050405090304"/>
              </a:rPr>
              <a:t>and </a:t>
            </a:r>
            <a:r>
              <a:rPr lang="en-US" altLang="zh-CN" sz="1200" i="1" dirty="0">
                <a:latin typeface="Times New Roman" panose="02020503050405090304"/>
                <a:ea typeface="Times New Roman" panose="02020503050405090304"/>
              </a:rPr>
              <a:t>LYAR</a:t>
            </a:r>
            <a:r>
              <a:rPr lang="en-US" altLang="zh-CN" sz="1200" dirty="0">
                <a:latin typeface="Times New Roman" panose="02020503050405090304"/>
                <a:ea typeface="Times New Roman" panose="02020503050405090304"/>
              </a:rPr>
              <a:t>)</a:t>
            </a:r>
            <a:endParaRPr lang="zh-CN" altLang="en-US" sz="12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 descr="Metabilism_GZMK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65785" y="454660"/>
            <a:ext cx="2870200" cy="2153920"/>
          </a:xfrm>
          <a:prstGeom prst="rect">
            <a:avLst/>
          </a:prstGeom>
        </p:spPr>
      </p:pic>
      <p:pic>
        <p:nvPicPr>
          <p:cNvPr id="17" name="图片 16" descr="Metabilism_LYAR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5785" y="5592445"/>
            <a:ext cx="2869565" cy="2153285"/>
          </a:xfrm>
          <a:prstGeom prst="rect">
            <a:avLst/>
          </a:prstGeom>
        </p:spPr>
      </p:pic>
      <p:pic>
        <p:nvPicPr>
          <p:cNvPr id="19" name="图片 18" descr="Metabilism_KLRG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785" y="2987675"/>
            <a:ext cx="2869565" cy="2153285"/>
          </a:xfrm>
          <a:prstGeom prst="rect">
            <a:avLst/>
          </a:prstGeom>
        </p:spPr>
      </p:pic>
      <p:sp>
        <p:nvSpPr>
          <p:cNvPr id="21" name="文本框 15"/>
          <p:cNvSpPr txBox="1"/>
          <p:nvPr/>
        </p:nvSpPr>
        <p:spPr>
          <a:xfrm>
            <a:off x="-24765" y="1310005"/>
            <a:ext cx="678815" cy="2470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 i="1" dirty="0">
                <a:latin typeface="Times New Roman" panose="02020503050405090304" pitchFamily="18" charset="0"/>
                <a:ea typeface="PingFang SC Semibold" panose="020B0400000000000000" charset="-122"/>
                <a:cs typeface="Times New Roman" panose="02020503050405090304" pitchFamily="18" charset="0"/>
              </a:rPr>
              <a:t>GZMK</a:t>
            </a:r>
            <a:endParaRPr lang="en-US" altLang="zh-CN" sz="1200" b="1" i="1" dirty="0">
              <a:latin typeface="Times New Roman" panose="02020503050405090304" pitchFamily="18" charset="0"/>
              <a:ea typeface="PingFang SC Semibold" panose="020B0400000000000000" charset="-122"/>
              <a:cs typeface="Times New Roman" panose="02020503050405090304" pitchFamily="18" charset="0"/>
            </a:endParaRPr>
          </a:p>
        </p:txBody>
      </p:sp>
      <p:sp>
        <p:nvSpPr>
          <p:cNvPr id="22" name="文本框 15"/>
          <p:cNvSpPr txBox="1"/>
          <p:nvPr/>
        </p:nvSpPr>
        <p:spPr>
          <a:xfrm>
            <a:off x="-24765" y="3785235"/>
            <a:ext cx="784225" cy="2470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 i="1" dirty="0">
                <a:latin typeface="Times New Roman" panose="02020503050405090304" pitchFamily="18" charset="0"/>
                <a:ea typeface="PingFang SC Semibold" panose="020B0400000000000000" charset="-122"/>
                <a:cs typeface="Times New Roman" panose="02020503050405090304" pitchFamily="18" charset="0"/>
              </a:rPr>
              <a:t>KLRG1</a:t>
            </a:r>
            <a:endParaRPr lang="en-US" altLang="zh-CN" sz="1200" b="1" i="1" dirty="0">
              <a:latin typeface="Times New Roman" panose="02020503050405090304" pitchFamily="18" charset="0"/>
              <a:ea typeface="PingFang SC Semibold" panose="020B0400000000000000" charset="-122"/>
              <a:cs typeface="Times New Roman" panose="02020503050405090304" pitchFamily="18" charset="0"/>
            </a:endParaRPr>
          </a:p>
        </p:txBody>
      </p:sp>
      <p:sp>
        <p:nvSpPr>
          <p:cNvPr id="23" name="文本框 15"/>
          <p:cNvSpPr txBox="1"/>
          <p:nvPr/>
        </p:nvSpPr>
        <p:spPr>
          <a:xfrm>
            <a:off x="-24765" y="6501130"/>
            <a:ext cx="784225" cy="2470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 i="1" dirty="0">
                <a:latin typeface="Times New Roman" panose="02020503050405090304" pitchFamily="18" charset="0"/>
                <a:ea typeface="PingFang SC Semibold" panose="020B0400000000000000" charset="-122"/>
                <a:cs typeface="Times New Roman" panose="02020503050405090304" pitchFamily="18" charset="0"/>
              </a:rPr>
              <a:t>LYAR</a:t>
            </a:r>
            <a:endParaRPr lang="en-US" altLang="zh-CN" sz="1200" b="1" i="1" dirty="0">
              <a:latin typeface="Times New Roman" panose="02020503050405090304" pitchFamily="18" charset="0"/>
              <a:ea typeface="PingFang SC Semibold" panose="020B0400000000000000" charset="-122"/>
              <a:cs typeface="Times New Roman" panose="0202050305040509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35915" y="177800"/>
            <a:ext cx="290195" cy="2470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 b="1" dirty="0">
                <a:latin typeface="Times New Roman" panose="02020503050405090304" pitchFamily="18" charset="0"/>
                <a:ea typeface="PingFang SC Semibold" panose="020B0400000000000000" charset="-122"/>
                <a:cs typeface="Times New Roman" panose="02020503050405090304" pitchFamily="18" charset="0"/>
              </a:rPr>
              <a:t>A</a:t>
            </a:r>
            <a:endParaRPr lang="en-US" altLang="zh-CN" sz="1200" b="1" dirty="0">
              <a:latin typeface="Times New Roman" panose="02020503050405090304" pitchFamily="18" charset="0"/>
              <a:ea typeface="PingFang SC Semibold" panose="020B0400000000000000" charset="-122"/>
              <a:cs typeface="Times New Roman" panose="02020503050405090304" pitchFamily="18" charset="0"/>
            </a:endParaRPr>
          </a:p>
        </p:txBody>
      </p:sp>
      <p:pic>
        <p:nvPicPr>
          <p:cNvPr id="4" name="图片 3" descr="pheatmap_bulk_gene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38575" y="454660"/>
            <a:ext cx="2780030" cy="370903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703955" y="177800"/>
            <a:ext cx="290195" cy="2470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 b="1" dirty="0">
                <a:latin typeface="Times New Roman" panose="02020503050405090304" pitchFamily="18" charset="0"/>
                <a:ea typeface="PingFang SC Semibold" panose="020B0400000000000000" charset="-122"/>
                <a:cs typeface="Times New Roman" panose="02020503050405090304" pitchFamily="18" charset="0"/>
              </a:rPr>
              <a:t>B</a:t>
            </a:r>
            <a:endParaRPr lang="en-US" altLang="zh-CN" sz="1200" b="1" dirty="0">
              <a:latin typeface="Times New Roman" panose="02020503050405090304" pitchFamily="18" charset="0"/>
              <a:ea typeface="PingFang SC Semibold" panose="020B0400000000000000" charset="-122"/>
              <a:cs typeface="Times New Roman" panose="0202050305040509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35915" y="8197215"/>
            <a:ext cx="6282690" cy="1085215"/>
          </a:xfrm>
          <a:prstGeom prst="rect">
            <a:avLst/>
          </a:prstGeom>
          <a:noFill/>
        </p:spPr>
        <p:txBody>
          <a:bodyPr wrap="square">
            <a:noAutofit/>
          </a:bodyPr>
          <a:p>
            <a:r>
              <a:rPr lang="en-US" altLang="zh-CN" sz="1200" dirty="0">
                <a:latin typeface="Times New Roman" panose="02020503050405090304"/>
                <a:ea typeface="Times New Roman" panose="02020503050405090304"/>
              </a:rPr>
              <a:t>Supplementary Figure 2. </a:t>
            </a:r>
            <a:r>
              <a:rPr lang="en-US" altLang="zh-CN" sz="1200" dirty="0">
                <a:latin typeface="Times New Roman" panose="02020503050405090304" pitchFamily="18" charset="0"/>
                <a:cs typeface="Times New Roman" panose="02020503050405090304" pitchFamily="18" charset="0"/>
              </a:rPr>
              <a:t>The bulk-RNA analysis in chronic periodontitis (CP). A, the major enrichment metabolic pathways of CD8_CM cell expressing and not expressing GZMK, KLRG1</a:t>
            </a:r>
            <a:r>
              <a:rPr lang="en-US" altLang="en-US" sz="1200" dirty="0">
                <a:latin typeface="Times New Roman" panose="02020503050405090304" pitchFamily="18" charset="0"/>
                <a:cs typeface="Times New Roman" panose="02020503050405090304" pitchFamily="18" charset="0"/>
              </a:rPr>
              <a:t> </a:t>
            </a:r>
            <a:r>
              <a:rPr lang="en-US" altLang="zh-CN" sz="1200" dirty="0">
                <a:latin typeface="Times New Roman" panose="02020503050405090304" pitchFamily="18" charset="0"/>
                <a:cs typeface="Times New Roman" panose="02020503050405090304" pitchFamily="18" charset="0"/>
              </a:rPr>
              <a:t>and LYAR and other T-cell types. B, the heatmap of expression levels.</a:t>
            </a:r>
            <a:endParaRPr lang="en-US" altLang="zh-CN" sz="1200" dirty="0">
              <a:latin typeface="Times New Roman" panose="02020503050405090304" pitchFamily="18" charset="0"/>
              <a:cs typeface="Times New Roman" panose="02020503050405090304" pitchFamily="18" charset="0"/>
            </a:endParaRPr>
          </a:p>
        </p:txBody>
      </p:sp>
    </p:spTree>
    <p:custDataLst>
      <p:tags r:id="rId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苹方-简"/>
        <a:ea typeface="苹方-简"/>
        <a:cs typeface=""/>
      </a:majorFont>
      <a:minorFont>
        <a:latin typeface="苹方-简"/>
        <a:ea typeface="苹方-简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WPS">
      <a:majorFont>
        <a:latin typeface="苹方-简"/>
        <a:ea typeface="苹方-简"/>
        <a:cs typeface=""/>
      </a:majorFont>
      <a:minorFont>
        <a:latin typeface="苹方-简"/>
        <a:ea typeface="苹方-简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WPS">
      <a:majorFont>
        <a:latin typeface="苹方-简"/>
        <a:ea typeface="苹方-简"/>
        <a:cs typeface=""/>
      </a:majorFont>
      <a:minorFont>
        <a:latin typeface="苹方-简"/>
        <a:ea typeface="苹方-简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5</Words>
  <Application>WPS 文字</Application>
  <PresentationFormat>Custom</PresentationFormat>
  <Paragraphs>14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6" baseType="lpstr">
      <vt:lpstr>Arial</vt:lpstr>
      <vt:lpstr>宋体</vt:lpstr>
      <vt:lpstr>Wingdings</vt:lpstr>
      <vt:lpstr>Wingdings</vt:lpstr>
      <vt:lpstr>Times New Roman</vt:lpstr>
      <vt:lpstr>PingFang SC Semibold</vt:lpstr>
      <vt:lpstr>Times New Roman</vt:lpstr>
      <vt:lpstr>宋体</vt:lpstr>
      <vt:lpstr>汉仪书宋二KW</vt:lpstr>
      <vt:lpstr>微软雅黑</vt:lpstr>
      <vt:lpstr>汉仪旗黑</vt:lpstr>
      <vt:lpstr>Arial Unicode MS</vt:lpstr>
      <vt:lpstr>苹方-简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WPS_1675249261</cp:lastModifiedBy>
  <cp:revision>215</cp:revision>
  <dcterms:created xsi:type="dcterms:W3CDTF">2026-06-03T09:59:04Z</dcterms:created>
  <dcterms:modified xsi:type="dcterms:W3CDTF">2026-06-03T09:59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22522.22522</vt:lpwstr>
  </property>
  <property fmtid="{D5CDD505-2E9C-101B-9397-08002B2CF9AE}" pid="3" name="ICV">
    <vt:lpwstr>2D5E7C6AC1C729EE4F95C269AE49CA48_43</vt:lpwstr>
  </property>
</Properties>
</file>